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7315200" cy="9144000"/>
  <p:notesSz cx="6858000" cy="9144000"/>
  <p:defaultTextStyle>
    <a:defPPr>
      <a:defRPr lang="en-US"/>
    </a:defPPr>
    <a:lvl1pPr marL="0" algn="l" defTabSz="153376" rtl="0" eaLnBrk="1" latinLnBrk="0" hangingPunct="1">
      <a:defRPr sz="634" kern="1200">
        <a:solidFill>
          <a:schemeClr val="tx1"/>
        </a:solidFill>
        <a:latin typeface="+mn-lt"/>
        <a:ea typeface="+mn-ea"/>
        <a:cs typeface="+mn-cs"/>
      </a:defRPr>
    </a:lvl1pPr>
    <a:lvl2pPr marL="153376" algn="l" defTabSz="153376" rtl="0" eaLnBrk="1" latinLnBrk="0" hangingPunct="1">
      <a:defRPr sz="634" kern="1200">
        <a:solidFill>
          <a:schemeClr val="tx1"/>
        </a:solidFill>
        <a:latin typeface="+mn-lt"/>
        <a:ea typeface="+mn-ea"/>
        <a:cs typeface="+mn-cs"/>
      </a:defRPr>
    </a:lvl2pPr>
    <a:lvl3pPr marL="306753" algn="l" defTabSz="153376" rtl="0" eaLnBrk="1" latinLnBrk="0" hangingPunct="1">
      <a:defRPr sz="634" kern="1200">
        <a:solidFill>
          <a:schemeClr val="tx1"/>
        </a:solidFill>
        <a:latin typeface="+mn-lt"/>
        <a:ea typeface="+mn-ea"/>
        <a:cs typeface="+mn-cs"/>
      </a:defRPr>
    </a:lvl3pPr>
    <a:lvl4pPr marL="460128" algn="l" defTabSz="153376" rtl="0" eaLnBrk="1" latinLnBrk="0" hangingPunct="1">
      <a:defRPr sz="634" kern="1200">
        <a:solidFill>
          <a:schemeClr val="tx1"/>
        </a:solidFill>
        <a:latin typeface="+mn-lt"/>
        <a:ea typeface="+mn-ea"/>
        <a:cs typeface="+mn-cs"/>
      </a:defRPr>
    </a:lvl4pPr>
    <a:lvl5pPr marL="613504" algn="l" defTabSz="153376" rtl="0" eaLnBrk="1" latinLnBrk="0" hangingPunct="1">
      <a:defRPr sz="634" kern="1200">
        <a:solidFill>
          <a:schemeClr val="tx1"/>
        </a:solidFill>
        <a:latin typeface="+mn-lt"/>
        <a:ea typeface="+mn-ea"/>
        <a:cs typeface="+mn-cs"/>
      </a:defRPr>
    </a:lvl5pPr>
    <a:lvl6pPr marL="766881" algn="l" defTabSz="153376" rtl="0" eaLnBrk="1" latinLnBrk="0" hangingPunct="1">
      <a:defRPr sz="634" kern="1200">
        <a:solidFill>
          <a:schemeClr val="tx1"/>
        </a:solidFill>
        <a:latin typeface="+mn-lt"/>
        <a:ea typeface="+mn-ea"/>
        <a:cs typeface="+mn-cs"/>
      </a:defRPr>
    </a:lvl6pPr>
    <a:lvl7pPr marL="920257" algn="l" defTabSz="153376" rtl="0" eaLnBrk="1" latinLnBrk="0" hangingPunct="1">
      <a:defRPr sz="634" kern="1200">
        <a:solidFill>
          <a:schemeClr val="tx1"/>
        </a:solidFill>
        <a:latin typeface="+mn-lt"/>
        <a:ea typeface="+mn-ea"/>
        <a:cs typeface="+mn-cs"/>
      </a:defRPr>
    </a:lvl7pPr>
    <a:lvl8pPr marL="1073634" algn="l" defTabSz="153376" rtl="0" eaLnBrk="1" latinLnBrk="0" hangingPunct="1">
      <a:defRPr sz="634" kern="1200">
        <a:solidFill>
          <a:schemeClr val="tx1"/>
        </a:solidFill>
        <a:latin typeface="+mn-lt"/>
        <a:ea typeface="+mn-ea"/>
        <a:cs typeface="+mn-cs"/>
      </a:defRPr>
    </a:lvl8pPr>
    <a:lvl9pPr marL="1227010" algn="l" defTabSz="153376" rtl="0" eaLnBrk="1" latinLnBrk="0" hangingPunct="1">
      <a:defRPr sz="63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3" userDrawn="1">
          <p15:clr>
            <a:srgbClr val="A4A3A4"/>
          </p15:clr>
        </p15:guide>
        <p15:guide id="2" pos="23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6272" autoAdjust="0"/>
  </p:normalViewPr>
  <p:slideViewPr>
    <p:cSldViewPr snapToGrid="0" snapToObjects="1">
      <p:cViewPr varScale="1">
        <p:scale>
          <a:sx n="94" d="100"/>
          <a:sy n="94" d="100"/>
        </p:scale>
        <p:origin x="2032" y="208"/>
      </p:cViewPr>
      <p:guideLst>
        <p:guide orient="horz" pos="2883"/>
        <p:guide pos="230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8" y="2840587"/>
            <a:ext cx="6217919" cy="196003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97289" y="5181616"/>
            <a:ext cx="5120641" cy="233679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6548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3097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79645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06194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3274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59291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85840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12389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97F44-DB72-474A-9754-31703E05C006}" type="datetimeFigureOut">
              <a:rPr lang="en-US" smtClean="0"/>
              <a:t>10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C371D-FBE1-FA40-BCA0-3BF395754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893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97F44-DB72-474A-9754-31703E05C006}" type="datetimeFigureOut">
              <a:rPr lang="en-US" smtClean="0"/>
              <a:t>10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C371D-FBE1-FA40-BCA0-3BF395754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309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03521" y="366200"/>
            <a:ext cx="1645920" cy="780203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5764" y="366200"/>
            <a:ext cx="4815840" cy="780203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97F44-DB72-474A-9754-31703E05C006}" type="datetimeFigureOut">
              <a:rPr lang="en-US" smtClean="0"/>
              <a:t>10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C371D-FBE1-FA40-BCA0-3BF395754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6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97F44-DB72-474A-9754-31703E05C006}" type="datetimeFigureOut">
              <a:rPr lang="en-US" smtClean="0"/>
              <a:t>10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C371D-FBE1-FA40-BCA0-3BF395754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385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7861" y="5875888"/>
            <a:ext cx="6217919" cy="1816106"/>
          </a:xfrm>
        </p:spPr>
        <p:txBody>
          <a:bodyPr anchor="t"/>
          <a:lstStyle>
            <a:lvl1pPr algn="l">
              <a:defRPr sz="23525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7861" y="3875632"/>
            <a:ext cx="6217919" cy="2000251"/>
          </a:xfrm>
        </p:spPr>
        <p:txBody>
          <a:bodyPr anchor="b"/>
          <a:lstStyle>
            <a:lvl1pPr marL="0" indent="0">
              <a:buNone/>
              <a:defRPr sz="12552">
                <a:solidFill>
                  <a:schemeClr val="tx1">
                    <a:tint val="75000"/>
                  </a:schemeClr>
                </a:solidFill>
              </a:defRPr>
            </a:lvl1pPr>
            <a:lvl2pPr marL="2654852" indent="0">
              <a:buNone/>
              <a:defRPr sz="10979">
                <a:solidFill>
                  <a:schemeClr val="tx1">
                    <a:tint val="75000"/>
                  </a:schemeClr>
                </a:solidFill>
              </a:defRPr>
            </a:lvl2pPr>
            <a:lvl3pPr marL="5309732" indent="0">
              <a:buNone/>
              <a:defRPr sz="9405">
                <a:solidFill>
                  <a:schemeClr val="tx1">
                    <a:tint val="75000"/>
                  </a:schemeClr>
                </a:solidFill>
              </a:defRPr>
            </a:lvl3pPr>
            <a:lvl4pPr marL="7964587" indent="0">
              <a:buNone/>
              <a:defRPr sz="7842">
                <a:solidFill>
                  <a:schemeClr val="tx1">
                    <a:tint val="75000"/>
                  </a:schemeClr>
                </a:solidFill>
              </a:defRPr>
            </a:lvl4pPr>
            <a:lvl5pPr marL="10619444" indent="0">
              <a:buNone/>
              <a:defRPr sz="7842">
                <a:solidFill>
                  <a:schemeClr val="tx1">
                    <a:tint val="75000"/>
                  </a:schemeClr>
                </a:solidFill>
              </a:defRPr>
            </a:lvl5pPr>
            <a:lvl6pPr marL="13274325" indent="0">
              <a:buNone/>
              <a:defRPr sz="7842">
                <a:solidFill>
                  <a:schemeClr val="tx1">
                    <a:tint val="75000"/>
                  </a:schemeClr>
                </a:solidFill>
              </a:defRPr>
            </a:lvl6pPr>
            <a:lvl7pPr marL="15929181" indent="0">
              <a:buNone/>
              <a:defRPr sz="7842">
                <a:solidFill>
                  <a:schemeClr val="tx1">
                    <a:tint val="75000"/>
                  </a:schemeClr>
                </a:solidFill>
              </a:defRPr>
            </a:lvl7pPr>
            <a:lvl8pPr marL="18584065" indent="0">
              <a:buNone/>
              <a:defRPr sz="7842">
                <a:solidFill>
                  <a:schemeClr val="tx1">
                    <a:tint val="75000"/>
                  </a:schemeClr>
                </a:solidFill>
              </a:defRPr>
            </a:lvl8pPr>
            <a:lvl9pPr marL="21238935" indent="0">
              <a:buNone/>
              <a:defRPr sz="784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97F44-DB72-474A-9754-31703E05C006}" type="datetimeFigureOut">
              <a:rPr lang="en-US" smtClean="0"/>
              <a:t>10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C371D-FBE1-FA40-BCA0-3BF395754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801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5770" y="2133624"/>
            <a:ext cx="3230881" cy="6034617"/>
          </a:xfrm>
        </p:spPr>
        <p:txBody>
          <a:bodyPr/>
          <a:lstStyle>
            <a:lvl1pPr>
              <a:defRPr sz="17250"/>
            </a:lvl1pPr>
            <a:lvl2pPr>
              <a:defRPr sz="14115"/>
            </a:lvl2pPr>
            <a:lvl3pPr>
              <a:defRPr sz="12552"/>
            </a:lvl3pPr>
            <a:lvl4pPr>
              <a:defRPr sz="10979"/>
            </a:lvl4pPr>
            <a:lvl5pPr>
              <a:defRPr sz="10979"/>
            </a:lvl5pPr>
            <a:lvl6pPr>
              <a:defRPr sz="10979"/>
            </a:lvl6pPr>
            <a:lvl7pPr>
              <a:defRPr sz="10979"/>
            </a:lvl7pPr>
            <a:lvl8pPr>
              <a:defRPr sz="10979"/>
            </a:lvl8pPr>
            <a:lvl9pPr>
              <a:defRPr sz="109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18570" y="2133624"/>
            <a:ext cx="3230881" cy="6034617"/>
          </a:xfrm>
        </p:spPr>
        <p:txBody>
          <a:bodyPr/>
          <a:lstStyle>
            <a:lvl1pPr>
              <a:defRPr sz="17250"/>
            </a:lvl1pPr>
            <a:lvl2pPr>
              <a:defRPr sz="14115"/>
            </a:lvl2pPr>
            <a:lvl3pPr>
              <a:defRPr sz="12552"/>
            </a:lvl3pPr>
            <a:lvl4pPr>
              <a:defRPr sz="10979"/>
            </a:lvl4pPr>
            <a:lvl5pPr>
              <a:defRPr sz="10979"/>
            </a:lvl5pPr>
            <a:lvl6pPr>
              <a:defRPr sz="10979"/>
            </a:lvl6pPr>
            <a:lvl7pPr>
              <a:defRPr sz="10979"/>
            </a:lvl7pPr>
            <a:lvl8pPr>
              <a:defRPr sz="10979"/>
            </a:lvl8pPr>
            <a:lvl9pPr>
              <a:defRPr sz="109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97F44-DB72-474A-9754-31703E05C006}" type="datetimeFigureOut">
              <a:rPr lang="en-US" smtClean="0"/>
              <a:t>10/2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C371D-FBE1-FA40-BCA0-3BF395754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973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772" y="2046830"/>
            <a:ext cx="3232151" cy="853014"/>
          </a:xfrm>
        </p:spPr>
        <p:txBody>
          <a:bodyPr anchor="b"/>
          <a:lstStyle>
            <a:lvl1pPr marL="0" indent="0">
              <a:buNone/>
              <a:defRPr sz="14115" b="1"/>
            </a:lvl1pPr>
            <a:lvl2pPr marL="2654852" indent="0">
              <a:buNone/>
              <a:defRPr sz="12552" b="1"/>
            </a:lvl2pPr>
            <a:lvl3pPr marL="5309732" indent="0">
              <a:buNone/>
              <a:defRPr sz="10979" b="1"/>
            </a:lvl3pPr>
            <a:lvl4pPr marL="7964587" indent="0">
              <a:buNone/>
              <a:defRPr sz="9405" b="1"/>
            </a:lvl4pPr>
            <a:lvl5pPr marL="10619444" indent="0">
              <a:buNone/>
              <a:defRPr sz="9405" b="1"/>
            </a:lvl5pPr>
            <a:lvl6pPr marL="13274325" indent="0">
              <a:buNone/>
              <a:defRPr sz="9405" b="1"/>
            </a:lvl6pPr>
            <a:lvl7pPr marL="15929181" indent="0">
              <a:buNone/>
              <a:defRPr sz="9405" b="1"/>
            </a:lvl7pPr>
            <a:lvl8pPr marL="18584065" indent="0">
              <a:buNone/>
              <a:defRPr sz="9405" b="1"/>
            </a:lvl8pPr>
            <a:lvl9pPr marL="21238935" indent="0">
              <a:buNone/>
              <a:defRPr sz="940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5772" y="2899841"/>
            <a:ext cx="3232151" cy="5268386"/>
          </a:xfrm>
        </p:spPr>
        <p:txBody>
          <a:bodyPr/>
          <a:lstStyle>
            <a:lvl1pPr>
              <a:defRPr sz="14115"/>
            </a:lvl1pPr>
            <a:lvl2pPr>
              <a:defRPr sz="12552"/>
            </a:lvl2pPr>
            <a:lvl3pPr>
              <a:defRPr sz="10979"/>
            </a:lvl3pPr>
            <a:lvl4pPr>
              <a:defRPr sz="9405"/>
            </a:lvl4pPr>
            <a:lvl5pPr>
              <a:defRPr sz="9405"/>
            </a:lvl5pPr>
            <a:lvl6pPr>
              <a:defRPr sz="9405"/>
            </a:lvl6pPr>
            <a:lvl7pPr>
              <a:defRPr sz="9405"/>
            </a:lvl7pPr>
            <a:lvl8pPr>
              <a:defRPr sz="9405"/>
            </a:lvl8pPr>
            <a:lvl9pPr>
              <a:defRPr sz="940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16028" y="2046830"/>
            <a:ext cx="3233420" cy="853014"/>
          </a:xfrm>
        </p:spPr>
        <p:txBody>
          <a:bodyPr anchor="b"/>
          <a:lstStyle>
            <a:lvl1pPr marL="0" indent="0">
              <a:buNone/>
              <a:defRPr sz="14115" b="1"/>
            </a:lvl1pPr>
            <a:lvl2pPr marL="2654852" indent="0">
              <a:buNone/>
              <a:defRPr sz="12552" b="1"/>
            </a:lvl2pPr>
            <a:lvl3pPr marL="5309732" indent="0">
              <a:buNone/>
              <a:defRPr sz="10979" b="1"/>
            </a:lvl3pPr>
            <a:lvl4pPr marL="7964587" indent="0">
              <a:buNone/>
              <a:defRPr sz="9405" b="1"/>
            </a:lvl4pPr>
            <a:lvl5pPr marL="10619444" indent="0">
              <a:buNone/>
              <a:defRPr sz="9405" b="1"/>
            </a:lvl5pPr>
            <a:lvl6pPr marL="13274325" indent="0">
              <a:buNone/>
              <a:defRPr sz="9405" b="1"/>
            </a:lvl6pPr>
            <a:lvl7pPr marL="15929181" indent="0">
              <a:buNone/>
              <a:defRPr sz="9405" b="1"/>
            </a:lvl7pPr>
            <a:lvl8pPr marL="18584065" indent="0">
              <a:buNone/>
              <a:defRPr sz="9405" b="1"/>
            </a:lvl8pPr>
            <a:lvl9pPr marL="21238935" indent="0">
              <a:buNone/>
              <a:defRPr sz="940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16028" y="2899841"/>
            <a:ext cx="3233420" cy="5268386"/>
          </a:xfrm>
        </p:spPr>
        <p:txBody>
          <a:bodyPr/>
          <a:lstStyle>
            <a:lvl1pPr>
              <a:defRPr sz="14115"/>
            </a:lvl1pPr>
            <a:lvl2pPr>
              <a:defRPr sz="12552"/>
            </a:lvl2pPr>
            <a:lvl3pPr>
              <a:defRPr sz="10979"/>
            </a:lvl3pPr>
            <a:lvl4pPr>
              <a:defRPr sz="9405"/>
            </a:lvl4pPr>
            <a:lvl5pPr>
              <a:defRPr sz="9405"/>
            </a:lvl5pPr>
            <a:lvl6pPr>
              <a:defRPr sz="9405"/>
            </a:lvl6pPr>
            <a:lvl7pPr>
              <a:defRPr sz="9405"/>
            </a:lvl7pPr>
            <a:lvl8pPr>
              <a:defRPr sz="9405"/>
            </a:lvl8pPr>
            <a:lvl9pPr>
              <a:defRPr sz="940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97F44-DB72-474A-9754-31703E05C006}" type="datetimeFigureOut">
              <a:rPr lang="en-US" smtClean="0"/>
              <a:t>10/23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C371D-FBE1-FA40-BCA0-3BF395754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288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97F44-DB72-474A-9754-31703E05C006}" type="datetimeFigureOut">
              <a:rPr lang="en-US" smtClean="0"/>
              <a:t>10/2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C371D-FBE1-FA40-BCA0-3BF395754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362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97F44-DB72-474A-9754-31703E05C006}" type="datetimeFigureOut">
              <a:rPr lang="en-US" smtClean="0"/>
              <a:t>10/23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C371D-FBE1-FA40-BCA0-3BF395754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014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5768" y="364087"/>
            <a:ext cx="2406649" cy="1549397"/>
          </a:xfrm>
        </p:spPr>
        <p:txBody>
          <a:bodyPr anchor="b"/>
          <a:lstStyle>
            <a:lvl1pPr algn="l">
              <a:defRPr sz="12552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60049" y="364082"/>
            <a:ext cx="4089401" cy="7804151"/>
          </a:xfrm>
        </p:spPr>
        <p:txBody>
          <a:bodyPr/>
          <a:lstStyle>
            <a:lvl1pPr>
              <a:defRPr sz="20394"/>
            </a:lvl1pPr>
            <a:lvl2pPr>
              <a:defRPr sz="17250"/>
            </a:lvl2pPr>
            <a:lvl3pPr>
              <a:defRPr sz="14115"/>
            </a:lvl3pPr>
            <a:lvl4pPr>
              <a:defRPr sz="12552"/>
            </a:lvl4pPr>
            <a:lvl5pPr>
              <a:defRPr sz="12552"/>
            </a:lvl5pPr>
            <a:lvl6pPr>
              <a:defRPr sz="12552"/>
            </a:lvl6pPr>
            <a:lvl7pPr>
              <a:defRPr sz="12552"/>
            </a:lvl7pPr>
            <a:lvl8pPr>
              <a:defRPr sz="12552"/>
            </a:lvl8pPr>
            <a:lvl9pPr>
              <a:defRPr sz="1255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5768" y="1913481"/>
            <a:ext cx="2406649" cy="6254753"/>
          </a:xfrm>
        </p:spPr>
        <p:txBody>
          <a:bodyPr/>
          <a:lstStyle>
            <a:lvl1pPr marL="0" indent="0">
              <a:buNone/>
              <a:defRPr sz="7842"/>
            </a:lvl1pPr>
            <a:lvl2pPr marL="2654852" indent="0">
              <a:buNone/>
              <a:defRPr sz="6273"/>
            </a:lvl2pPr>
            <a:lvl3pPr marL="5309732" indent="0">
              <a:buNone/>
              <a:defRPr sz="4704"/>
            </a:lvl3pPr>
            <a:lvl4pPr marL="7964587" indent="0">
              <a:buNone/>
              <a:defRPr sz="4704"/>
            </a:lvl4pPr>
            <a:lvl5pPr marL="10619444" indent="0">
              <a:buNone/>
              <a:defRPr sz="4704"/>
            </a:lvl5pPr>
            <a:lvl6pPr marL="13274325" indent="0">
              <a:buNone/>
              <a:defRPr sz="4704"/>
            </a:lvl6pPr>
            <a:lvl7pPr marL="15929181" indent="0">
              <a:buNone/>
              <a:defRPr sz="4704"/>
            </a:lvl7pPr>
            <a:lvl8pPr marL="18584065" indent="0">
              <a:buNone/>
              <a:defRPr sz="4704"/>
            </a:lvl8pPr>
            <a:lvl9pPr marL="21238935" indent="0">
              <a:buNone/>
              <a:defRPr sz="470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97F44-DB72-474A-9754-31703E05C006}" type="datetimeFigureOut">
              <a:rPr lang="en-US" smtClean="0"/>
              <a:t>10/2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C371D-FBE1-FA40-BCA0-3BF395754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700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33833" y="6400820"/>
            <a:ext cx="4389120" cy="755647"/>
          </a:xfrm>
        </p:spPr>
        <p:txBody>
          <a:bodyPr anchor="b"/>
          <a:lstStyle>
            <a:lvl1pPr algn="l">
              <a:defRPr sz="12552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33833" y="817036"/>
            <a:ext cx="4389120" cy="5486400"/>
          </a:xfrm>
        </p:spPr>
        <p:txBody>
          <a:bodyPr/>
          <a:lstStyle>
            <a:lvl1pPr marL="0" indent="0">
              <a:buNone/>
              <a:defRPr sz="20394"/>
            </a:lvl1pPr>
            <a:lvl2pPr marL="2654852" indent="0">
              <a:buNone/>
              <a:defRPr sz="17250"/>
            </a:lvl2pPr>
            <a:lvl3pPr marL="5309732" indent="0">
              <a:buNone/>
              <a:defRPr sz="14115"/>
            </a:lvl3pPr>
            <a:lvl4pPr marL="7964587" indent="0">
              <a:buNone/>
              <a:defRPr sz="12552"/>
            </a:lvl4pPr>
            <a:lvl5pPr marL="10619444" indent="0">
              <a:buNone/>
              <a:defRPr sz="12552"/>
            </a:lvl5pPr>
            <a:lvl6pPr marL="13274325" indent="0">
              <a:buNone/>
              <a:defRPr sz="12552"/>
            </a:lvl6pPr>
            <a:lvl7pPr marL="15929181" indent="0">
              <a:buNone/>
              <a:defRPr sz="12552"/>
            </a:lvl7pPr>
            <a:lvl8pPr marL="18584065" indent="0">
              <a:buNone/>
              <a:defRPr sz="12552"/>
            </a:lvl8pPr>
            <a:lvl9pPr marL="21238935" indent="0">
              <a:buNone/>
              <a:defRPr sz="12552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33833" y="7156464"/>
            <a:ext cx="4389120" cy="1073153"/>
          </a:xfrm>
        </p:spPr>
        <p:txBody>
          <a:bodyPr/>
          <a:lstStyle>
            <a:lvl1pPr marL="0" indent="0">
              <a:buNone/>
              <a:defRPr sz="7842"/>
            </a:lvl1pPr>
            <a:lvl2pPr marL="2654852" indent="0">
              <a:buNone/>
              <a:defRPr sz="6273"/>
            </a:lvl2pPr>
            <a:lvl3pPr marL="5309732" indent="0">
              <a:buNone/>
              <a:defRPr sz="4704"/>
            </a:lvl3pPr>
            <a:lvl4pPr marL="7964587" indent="0">
              <a:buNone/>
              <a:defRPr sz="4704"/>
            </a:lvl4pPr>
            <a:lvl5pPr marL="10619444" indent="0">
              <a:buNone/>
              <a:defRPr sz="4704"/>
            </a:lvl5pPr>
            <a:lvl6pPr marL="13274325" indent="0">
              <a:buNone/>
              <a:defRPr sz="4704"/>
            </a:lvl6pPr>
            <a:lvl7pPr marL="15929181" indent="0">
              <a:buNone/>
              <a:defRPr sz="4704"/>
            </a:lvl7pPr>
            <a:lvl8pPr marL="18584065" indent="0">
              <a:buNone/>
              <a:defRPr sz="4704"/>
            </a:lvl8pPr>
            <a:lvl9pPr marL="21238935" indent="0">
              <a:buNone/>
              <a:defRPr sz="470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97F44-DB72-474A-9754-31703E05C006}" type="datetimeFigureOut">
              <a:rPr lang="en-US" smtClean="0"/>
              <a:t>10/2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C371D-FBE1-FA40-BCA0-3BF395754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904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5769" y="366194"/>
            <a:ext cx="6583681" cy="1524000"/>
          </a:xfrm>
          <a:prstGeom prst="rect">
            <a:avLst/>
          </a:prstGeom>
        </p:spPr>
        <p:txBody>
          <a:bodyPr vert="horz" lIns="67711" tIns="33854" rIns="67711" bIns="33854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769" y="2133624"/>
            <a:ext cx="6583681" cy="6034617"/>
          </a:xfrm>
          <a:prstGeom prst="rect">
            <a:avLst/>
          </a:prstGeom>
        </p:spPr>
        <p:txBody>
          <a:bodyPr vert="horz" lIns="67711" tIns="33854" rIns="67711" bIns="33854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5760" y="8475146"/>
            <a:ext cx="1706880" cy="486833"/>
          </a:xfrm>
          <a:prstGeom prst="rect">
            <a:avLst/>
          </a:prstGeom>
        </p:spPr>
        <p:txBody>
          <a:bodyPr vert="horz" lIns="67711" tIns="33854" rIns="67711" bIns="33854" rtlCol="0" anchor="ctr"/>
          <a:lstStyle>
            <a:lvl1pPr algn="l">
              <a:defRPr sz="62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97F44-DB72-474A-9754-31703E05C006}" type="datetimeFigureOut">
              <a:rPr lang="en-US" smtClean="0"/>
              <a:t>10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99365" y="8475146"/>
            <a:ext cx="2316481" cy="486833"/>
          </a:xfrm>
          <a:prstGeom prst="rect">
            <a:avLst/>
          </a:prstGeom>
        </p:spPr>
        <p:txBody>
          <a:bodyPr vert="horz" lIns="67711" tIns="33854" rIns="67711" bIns="33854" rtlCol="0" anchor="ctr"/>
          <a:lstStyle>
            <a:lvl1pPr algn="ctr">
              <a:defRPr sz="62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242560" y="8475146"/>
            <a:ext cx="1706880" cy="486833"/>
          </a:xfrm>
          <a:prstGeom prst="rect">
            <a:avLst/>
          </a:prstGeom>
        </p:spPr>
        <p:txBody>
          <a:bodyPr vert="horz" lIns="67711" tIns="33854" rIns="67711" bIns="33854" rtlCol="0" anchor="ctr"/>
          <a:lstStyle>
            <a:lvl1pPr algn="r">
              <a:defRPr sz="62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C371D-FBE1-FA40-BCA0-3BF395754D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995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654852" rtl="0" eaLnBrk="1" latinLnBrk="0" hangingPunct="1">
        <a:spcBef>
          <a:spcPct val="0"/>
        </a:spcBef>
        <a:buNone/>
        <a:defRPr sz="250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91139" indent="-1991139" algn="l" defTabSz="2654852" rtl="0" eaLnBrk="1" latinLnBrk="0" hangingPunct="1">
        <a:spcBef>
          <a:spcPct val="20000"/>
        </a:spcBef>
        <a:buFont typeface="Arial"/>
        <a:buChar char="•"/>
        <a:defRPr sz="20394" kern="1200">
          <a:solidFill>
            <a:schemeClr val="tx1"/>
          </a:solidFill>
          <a:latin typeface="+mn-lt"/>
          <a:ea typeface="+mn-ea"/>
          <a:cs typeface="+mn-cs"/>
        </a:defRPr>
      </a:lvl1pPr>
      <a:lvl2pPr marL="4314162" indent="-1659281" algn="l" defTabSz="2654852" rtl="0" eaLnBrk="1" latinLnBrk="0" hangingPunct="1">
        <a:spcBef>
          <a:spcPct val="20000"/>
        </a:spcBef>
        <a:buFont typeface="Arial"/>
        <a:buChar char="–"/>
        <a:defRPr sz="17250" kern="1200">
          <a:solidFill>
            <a:schemeClr val="tx1"/>
          </a:solidFill>
          <a:latin typeface="+mn-lt"/>
          <a:ea typeface="+mn-ea"/>
          <a:cs typeface="+mn-cs"/>
        </a:defRPr>
      </a:lvl2pPr>
      <a:lvl3pPr marL="6637165" indent="-1327416" algn="l" defTabSz="2654852" rtl="0" eaLnBrk="1" latinLnBrk="0" hangingPunct="1">
        <a:spcBef>
          <a:spcPct val="20000"/>
        </a:spcBef>
        <a:buFont typeface="Arial"/>
        <a:buChar char="•"/>
        <a:defRPr sz="14115" kern="1200">
          <a:solidFill>
            <a:schemeClr val="tx1"/>
          </a:solidFill>
          <a:latin typeface="+mn-lt"/>
          <a:ea typeface="+mn-ea"/>
          <a:cs typeface="+mn-cs"/>
        </a:defRPr>
      </a:lvl3pPr>
      <a:lvl4pPr marL="9292017" indent="-1327416" algn="l" defTabSz="2654852" rtl="0" eaLnBrk="1" latinLnBrk="0" hangingPunct="1">
        <a:spcBef>
          <a:spcPct val="20000"/>
        </a:spcBef>
        <a:buFont typeface="Arial"/>
        <a:buChar char="–"/>
        <a:defRPr sz="12552" kern="1200">
          <a:solidFill>
            <a:schemeClr val="tx1"/>
          </a:solidFill>
          <a:latin typeface="+mn-lt"/>
          <a:ea typeface="+mn-ea"/>
          <a:cs typeface="+mn-cs"/>
        </a:defRPr>
      </a:lvl4pPr>
      <a:lvl5pPr marL="11946897" indent="-1327416" algn="l" defTabSz="2654852" rtl="0" eaLnBrk="1" latinLnBrk="0" hangingPunct="1">
        <a:spcBef>
          <a:spcPct val="20000"/>
        </a:spcBef>
        <a:buFont typeface="Arial"/>
        <a:buChar char="»"/>
        <a:defRPr sz="12552" kern="1200">
          <a:solidFill>
            <a:schemeClr val="tx1"/>
          </a:solidFill>
          <a:latin typeface="+mn-lt"/>
          <a:ea typeface="+mn-ea"/>
          <a:cs typeface="+mn-cs"/>
        </a:defRPr>
      </a:lvl5pPr>
      <a:lvl6pPr marL="14601769" indent="-1327416" algn="l" defTabSz="2654852" rtl="0" eaLnBrk="1" latinLnBrk="0" hangingPunct="1">
        <a:spcBef>
          <a:spcPct val="20000"/>
        </a:spcBef>
        <a:buFont typeface="Arial"/>
        <a:buChar char="•"/>
        <a:defRPr sz="12552" kern="1200">
          <a:solidFill>
            <a:schemeClr val="tx1"/>
          </a:solidFill>
          <a:latin typeface="+mn-lt"/>
          <a:ea typeface="+mn-ea"/>
          <a:cs typeface="+mn-cs"/>
        </a:defRPr>
      </a:lvl6pPr>
      <a:lvl7pPr marL="17256640" indent="-1327416" algn="l" defTabSz="2654852" rtl="0" eaLnBrk="1" latinLnBrk="0" hangingPunct="1">
        <a:spcBef>
          <a:spcPct val="20000"/>
        </a:spcBef>
        <a:buFont typeface="Arial"/>
        <a:buChar char="•"/>
        <a:defRPr sz="12552" kern="1200">
          <a:solidFill>
            <a:schemeClr val="tx1"/>
          </a:solidFill>
          <a:latin typeface="+mn-lt"/>
          <a:ea typeface="+mn-ea"/>
          <a:cs typeface="+mn-cs"/>
        </a:defRPr>
      </a:lvl7pPr>
      <a:lvl8pPr marL="19911488" indent="-1327416" algn="l" defTabSz="2654852" rtl="0" eaLnBrk="1" latinLnBrk="0" hangingPunct="1">
        <a:spcBef>
          <a:spcPct val="20000"/>
        </a:spcBef>
        <a:buFont typeface="Arial"/>
        <a:buChar char="•"/>
        <a:defRPr sz="12552" kern="1200">
          <a:solidFill>
            <a:schemeClr val="tx1"/>
          </a:solidFill>
          <a:latin typeface="+mn-lt"/>
          <a:ea typeface="+mn-ea"/>
          <a:cs typeface="+mn-cs"/>
        </a:defRPr>
      </a:lvl8pPr>
      <a:lvl9pPr marL="22566368" indent="-1327416" algn="l" defTabSz="2654852" rtl="0" eaLnBrk="1" latinLnBrk="0" hangingPunct="1">
        <a:spcBef>
          <a:spcPct val="20000"/>
        </a:spcBef>
        <a:buFont typeface="Arial"/>
        <a:buChar char="•"/>
        <a:defRPr sz="1255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654852" rtl="0" eaLnBrk="1" latinLnBrk="0" hangingPunct="1">
        <a:defRPr sz="10979" kern="1200">
          <a:solidFill>
            <a:schemeClr val="tx1"/>
          </a:solidFill>
          <a:latin typeface="+mn-lt"/>
          <a:ea typeface="+mn-ea"/>
          <a:cs typeface="+mn-cs"/>
        </a:defRPr>
      </a:lvl1pPr>
      <a:lvl2pPr marL="2654852" algn="l" defTabSz="2654852" rtl="0" eaLnBrk="1" latinLnBrk="0" hangingPunct="1">
        <a:defRPr sz="10979" kern="1200">
          <a:solidFill>
            <a:schemeClr val="tx1"/>
          </a:solidFill>
          <a:latin typeface="+mn-lt"/>
          <a:ea typeface="+mn-ea"/>
          <a:cs typeface="+mn-cs"/>
        </a:defRPr>
      </a:lvl2pPr>
      <a:lvl3pPr marL="5309732" algn="l" defTabSz="2654852" rtl="0" eaLnBrk="1" latinLnBrk="0" hangingPunct="1">
        <a:defRPr sz="10979" kern="1200">
          <a:solidFill>
            <a:schemeClr val="tx1"/>
          </a:solidFill>
          <a:latin typeface="+mn-lt"/>
          <a:ea typeface="+mn-ea"/>
          <a:cs typeface="+mn-cs"/>
        </a:defRPr>
      </a:lvl3pPr>
      <a:lvl4pPr marL="7964587" algn="l" defTabSz="2654852" rtl="0" eaLnBrk="1" latinLnBrk="0" hangingPunct="1">
        <a:defRPr sz="10979" kern="1200">
          <a:solidFill>
            <a:schemeClr val="tx1"/>
          </a:solidFill>
          <a:latin typeface="+mn-lt"/>
          <a:ea typeface="+mn-ea"/>
          <a:cs typeface="+mn-cs"/>
        </a:defRPr>
      </a:lvl4pPr>
      <a:lvl5pPr marL="10619444" algn="l" defTabSz="2654852" rtl="0" eaLnBrk="1" latinLnBrk="0" hangingPunct="1">
        <a:defRPr sz="10979" kern="1200">
          <a:solidFill>
            <a:schemeClr val="tx1"/>
          </a:solidFill>
          <a:latin typeface="+mn-lt"/>
          <a:ea typeface="+mn-ea"/>
          <a:cs typeface="+mn-cs"/>
        </a:defRPr>
      </a:lvl5pPr>
      <a:lvl6pPr marL="13274325" algn="l" defTabSz="2654852" rtl="0" eaLnBrk="1" latinLnBrk="0" hangingPunct="1">
        <a:defRPr sz="10979" kern="1200">
          <a:solidFill>
            <a:schemeClr val="tx1"/>
          </a:solidFill>
          <a:latin typeface="+mn-lt"/>
          <a:ea typeface="+mn-ea"/>
          <a:cs typeface="+mn-cs"/>
        </a:defRPr>
      </a:lvl6pPr>
      <a:lvl7pPr marL="15929181" algn="l" defTabSz="2654852" rtl="0" eaLnBrk="1" latinLnBrk="0" hangingPunct="1">
        <a:defRPr sz="10979" kern="1200">
          <a:solidFill>
            <a:schemeClr val="tx1"/>
          </a:solidFill>
          <a:latin typeface="+mn-lt"/>
          <a:ea typeface="+mn-ea"/>
          <a:cs typeface="+mn-cs"/>
        </a:defRPr>
      </a:lvl7pPr>
      <a:lvl8pPr marL="18584065" algn="l" defTabSz="2654852" rtl="0" eaLnBrk="1" latinLnBrk="0" hangingPunct="1">
        <a:defRPr sz="10979" kern="1200">
          <a:solidFill>
            <a:schemeClr val="tx1"/>
          </a:solidFill>
          <a:latin typeface="+mn-lt"/>
          <a:ea typeface="+mn-ea"/>
          <a:cs typeface="+mn-cs"/>
        </a:defRPr>
      </a:lvl8pPr>
      <a:lvl9pPr marL="21238935" algn="l" defTabSz="2654852" rtl="0" eaLnBrk="1" latinLnBrk="0" hangingPunct="1">
        <a:defRPr sz="1097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ounded Rectangle 5">
            <a:extLst>
              <a:ext uri="{FF2B5EF4-FFF2-40B4-BE49-F238E27FC236}">
                <a16:creationId xmlns:a16="http://schemas.microsoft.com/office/drawing/2014/main" id="{46D93903-83B6-5F47-832C-D8B51B769FDB}"/>
              </a:ext>
            </a:extLst>
          </p:cNvPr>
          <p:cNvSpPr/>
          <p:nvPr/>
        </p:nvSpPr>
        <p:spPr>
          <a:xfrm>
            <a:off x="2436237" y="0"/>
            <a:ext cx="2442725" cy="62891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Knockdown experiment (CAGE-seq) for lncRNA X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917644E4-6D06-D74C-B901-2144E63F524F}"/>
              </a:ext>
            </a:extLst>
          </p:cNvPr>
          <p:cNvCxnSpPr>
            <a:cxnSpLocks/>
          </p:cNvCxnSpPr>
          <p:nvPr/>
        </p:nvCxnSpPr>
        <p:spPr>
          <a:xfrm>
            <a:off x="3657599" y="628918"/>
            <a:ext cx="0" cy="42308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" name="Rounded Rectangle 7">
            <a:extLst>
              <a:ext uri="{FF2B5EF4-FFF2-40B4-BE49-F238E27FC236}">
                <a16:creationId xmlns:a16="http://schemas.microsoft.com/office/drawing/2014/main" id="{BE18DEA2-FBE2-0848-BFE5-7847C8013310}"/>
              </a:ext>
            </a:extLst>
          </p:cNvPr>
          <p:cNvSpPr/>
          <p:nvPr/>
        </p:nvSpPr>
        <p:spPr>
          <a:xfrm>
            <a:off x="2436237" y="1173713"/>
            <a:ext cx="2442725" cy="62891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N differentially expressed (DE) promoters</a:t>
            </a:r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DEFC37AE-596B-9F47-AAFC-37AF7DE41B60}"/>
              </a:ext>
            </a:extLst>
          </p:cNvPr>
          <p:cNvSpPr/>
          <p:nvPr/>
        </p:nvSpPr>
        <p:spPr>
          <a:xfrm>
            <a:off x="54592" y="2551578"/>
            <a:ext cx="2442725" cy="84783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The sequences of the N DE-promoters + 1 kb downstream</a:t>
            </a:r>
          </a:p>
        </p:txBody>
      </p:sp>
      <p:sp>
        <p:nvSpPr>
          <p:cNvPr id="11" name="Rounded Rectangle 10">
            <a:extLst>
              <a:ext uri="{FF2B5EF4-FFF2-40B4-BE49-F238E27FC236}">
                <a16:creationId xmlns:a16="http://schemas.microsoft.com/office/drawing/2014/main" id="{5022501F-7629-E644-A8DA-3FB43305035C}"/>
              </a:ext>
            </a:extLst>
          </p:cNvPr>
          <p:cNvSpPr/>
          <p:nvPr/>
        </p:nvSpPr>
        <p:spPr>
          <a:xfrm>
            <a:off x="54592" y="4052832"/>
            <a:ext cx="2442725" cy="84783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Sample N background promoter regions with similar length and GC%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7AF2FD96-B9E1-0D4C-AABC-D7DE147E13CA}"/>
              </a:ext>
            </a:extLst>
          </p:cNvPr>
          <p:cNvCxnSpPr>
            <a:cxnSpLocks/>
          </p:cNvCxnSpPr>
          <p:nvPr/>
        </p:nvCxnSpPr>
        <p:spPr>
          <a:xfrm flipH="1">
            <a:off x="1460310" y="1884513"/>
            <a:ext cx="1951629" cy="53226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AD053BD2-463F-BF46-A0F7-23B99523732B}"/>
              </a:ext>
            </a:extLst>
          </p:cNvPr>
          <p:cNvCxnSpPr>
            <a:cxnSpLocks/>
          </p:cNvCxnSpPr>
          <p:nvPr/>
        </p:nvCxnSpPr>
        <p:spPr>
          <a:xfrm>
            <a:off x="3896546" y="1884513"/>
            <a:ext cx="1951631" cy="57153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25CCCCE2-2D04-0A4D-B30C-85050211E3E0}"/>
              </a:ext>
            </a:extLst>
          </p:cNvPr>
          <p:cNvCxnSpPr>
            <a:cxnSpLocks/>
          </p:cNvCxnSpPr>
          <p:nvPr/>
        </p:nvCxnSpPr>
        <p:spPr>
          <a:xfrm>
            <a:off x="1228075" y="3535892"/>
            <a:ext cx="0" cy="42252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" name="Rounded Rectangle 17">
            <a:extLst>
              <a:ext uri="{FF2B5EF4-FFF2-40B4-BE49-F238E27FC236}">
                <a16:creationId xmlns:a16="http://schemas.microsoft.com/office/drawing/2014/main" id="{004CF0F4-0CE9-F54B-AE04-D330BF50182E}"/>
              </a:ext>
            </a:extLst>
          </p:cNvPr>
          <p:cNvSpPr/>
          <p:nvPr/>
        </p:nvSpPr>
        <p:spPr>
          <a:xfrm>
            <a:off x="4817883" y="2551578"/>
            <a:ext cx="2442725" cy="84783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Sequences of the N transcripts (the longest isoform of DE-promoter)</a:t>
            </a:r>
          </a:p>
        </p:txBody>
      </p:sp>
      <p:sp>
        <p:nvSpPr>
          <p:cNvPr id="19" name="Rounded Rectangle 18">
            <a:extLst>
              <a:ext uri="{FF2B5EF4-FFF2-40B4-BE49-F238E27FC236}">
                <a16:creationId xmlns:a16="http://schemas.microsoft.com/office/drawing/2014/main" id="{9466A810-E038-D04C-98B8-4127B1FEE8EB}"/>
              </a:ext>
            </a:extLst>
          </p:cNvPr>
          <p:cNvSpPr/>
          <p:nvPr/>
        </p:nvSpPr>
        <p:spPr>
          <a:xfrm>
            <a:off x="4831308" y="4052832"/>
            <a:ext cx="2442725" cy="84783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Sample N background transcripts with similar length and GC%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17D28977-5806-0B48-9A01-7C74E0EDA506}"/>
              </a:ext>
            </a:extLst>
          </p:cNvPr>
          <p:cNvCxnSpPr>
            <a:cxnSpLocks/>
          </p:cNvCxnSpPr>
          <p:nvPr/>
        </p:nvCxnSpPr>
        <p:spPr>
          <a:xfrm>
            <a:off x="6004791" y="3535892"/>
            <a:ext cx="0" cy="42252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2" name="Rounded Rectangle 21">
            <a:extLst>
              <a:ext uri="{FF2B5EF4-FFF2-40B4-BE49-F238E27FC236}">
                <a16:creationId xmlns:a16="http://schemas.microsoft.com/office/drawing/2014/main" id="{B77654BA-036B-3749-8634-902F7D96EB6D}"/>
              </a:ext>
            </a:extLst>
          </p:cNvPr>
          <p:cNvSpPr/>
          <p:nvPr/>
        </p:nvSpPr>
        <p:spPr>
          <a:xfrm>
            <a:off x="54591" y="5471645"/>
            <a:ext cx="2442725" cy="62891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2N sequences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05EB4B90-E9AD-1249-8C47-82E104146D5E}"/>
              </a:ext>
            </a:extLst>
          </p:cNvPr>
          <p:cNvCxnSpPr>
            <a:cxnSpLocks/>
          </p:cNvCxnSpPr>
          <p:nvPr/>
        </p:nvCxnSpPr>
        <p:spPr>
          <a:xfrm>
            <a:off x="1228075" y="4968907"/>
            <a:ext cx="0" cy="42252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Rounded Rectangle 23">
            <a:extLst>
              <a:ext uri="{FF2B5EF4-FFF2-40B4-BE49-F238E27FC236}">
                <a16:creationId xmlns:a16="http://schemas.microsoft.com/office/drawing/2014/main" id="{8DB53CB8-8A93-B545-A1AD-AD806E79473C}"/>
              </a:ext>
            </a:extLst>
          </p:cNvPr>
          <p:cNvSpPr/>
          <p:nvPr/>
        </p:nvSpPr>
        <p:spPr>
          <a:xfrm>
            <a:off x="4831308" y="5471645"/>
            <a:ext cx="2442725" cy="62891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2N sequences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084A80AE-0882-0445-96A8-BC2F4FE43EEE}"/>
              </a:ext>
            </a:extLst>
          </p:cNvPr>
          <p:cNvCxnSpPr>
            <a:cxnSpLocks/>
          </p:cNvCxnSpPr>
          <p:nvPr/>
        </p:nvCxnSpPr>
        <p:spPr>
          <a:xfrm>
            <a:off x="6004792" y="4968907"/>
            <a:ext cx="0" cy="42252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C45577A2-32B4-1945-993A-9D82B6B25600}"/>
              </a:ext>
            </a:extLst>
          </p:cNvPr>
          <p:cNvCxnSpPr>
            <a:cxnSpLocks/>
          </p:cNvCxnSpPr>
          <p:nvPr/>
        </p:nvCxnSpPr>
        <p:spPr>
          <a:xfrm flipH="1">
            <a:off x="2606722" y="5786103"/>
            <a:ext cx="45037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33BFD6BF-CFDB-A141-9A35-3A971C1E7187}"/>
              </a:ext>
            </a:extLst>
          </p:cNvPr>
          <p:cNvCxnSpPr>
            <a:cxnSpLocks/>
          </p:cNvCxnSpPr>
          <p:nvPr/>
        </p:nvCxnSpPr>
        <p:spPr>
          <a:xfrm flipH="1">
            <a:off x="2606722" y="2919235"/>
            <a:ext cx="450376" cy="0"/>
          </a:xfrm>
          <a:prstGeom prst="straightConnector1">
            <a:avLst/>
          </a:prstGeom>
          <a:ln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F4196BB9-A20E-1944-965C-7EE6B3C81AC7}"/>
              </a:ext>
            </a:extLst>
          </p:cNvPr>
          <p:cNvCxnSpPr>
            <a:cxnSpLocks/>
          </p:cNvCxnSpPr>
          <p:nvPr/>
        </p:nvCxnSpPr>
        <p:spPr>
          <a:xfrm flipH="1">
            <a:off x="3070745" y="2908513"/>
            <a:ext cx="1" cy="2877590"/>
          </a:xfrm>
          <a:prstGeom prst="straightConnector1">
            <a:avLst/>
          </a:prstGeom>
          <a:ln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2397C330-EA3F-974A-8F85-13F7E633ED0E}"/>
              </a:ext>
            </a:extLst>
          </p:cNvPr>
          <p:cNvCxnSpPr>
            <a:cxnSpLocks/>
          </p:cNvCxnSpPr>
          <p:nvPr/>
        </p:nvCxnSpPr>
        <p:spPr>
          <a:xfrm flipH="1">
            <a:off x="4299044" y="2908513"/>
            <a:ext cx="1" cy="2877590"/>
          </a:xfrm>
          <a:prstGeom prst="straightConnector1">
            <a:avLst/>
          </a:prstGeom>
          <a:ln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272F5A02-BD20-1D46-AB44-169542B94C6B}"/>
              </a:ext>
            </a:extLst>
          </p:cNvPr>
          <p:cNvCxnSpPr>
            <a:cxnSpLocks/>
          </p:cNvCxnSpPr>
          <p:nvPr/>
        </p:nvCxnSpPr>
        <p:spPr>
          <a:xfrm flipH="1">
            <a:off x="4299045" y="2919235"/>
            <a:ext cx="450376" cy="0"/>
          </a:xfrm>
          <a:prstGeom prst="straightConnector1">
            <a:avLst/>
          </a:prstGeom>
          <a:ln>
            <a:tailEnd type="non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D96729EB-C336-804C-B3A7-68E47C9D56F0}"/>
              </a:ext>
            </a:extLst>
          </p:cNvPr>
          <p:cNvCxnSpPr>
            <a:cxnSpLocks/>
          </p:cNvCxnSpPr>
          <p:nvPr/>
        </p:nvCxnSpPr>
        <p:spPr>
          <a:xfrm>
            <a:off x="4299044" y="5784433"/>
            <a:ext cx="450377" cy="167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Rounded Rectangle 38">
            <a:extLst>
              <a:ext uri="{FF2B5EF4-FFF2-40B4-BE49-F238E27FC236}">
                <a16:creationId xmlns:a16="http://schemas.microsoft.com/office/drawing/2014/main" id="{ECDAF5C0-16FA-614C-BD92-6A84419FDD28}"/>
              </a:ext>
            </a:extLst>
          </p:cNvPr>
          <p:cNvSpPr/>
          <p:nvPr/>
        </p:nvSpPr>
        <p:spPr>
          <a:xfrm>
            <a:off x="2975211" y="6619719"/>
            <a:ext cx="1364775" cy="628916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Sequence of the lncRNA X</a:t>
            </a:r>
          </a:p>
        </p:txBody>
      </p:sp>
      <p:sp>
        <p:nvSpPr>
          <p:cNvPr id="40" name="Rounded Rectangle 39">
            <a:extLst>
              <a:ext uri="{FF2B5EF4-FFF2-40B4-BE49-F238E27FC236}">
                <a16:creationId xmlns:a16="http://schemas.microsoft.com/office/drawing/2014/main" id="{120D5C60-B9AD-5646-B849-C1C2899CC007}"/>
              </a:ext>
            </a:extLst>
          </p:cNvPr>
          <p:cNvSpPr/>
          <p:nvPr/>
        </p:nvSpPr>
        <p:spPr>
          <a:xfrm>
            <a:off x="54591" y="6620826"/>
            <a:ext cx="2442725" cy="628916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Run ASSA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FA44F35D-7267-C242-9FCD-816F0B9AF8E0}"/>
              </a:ext>
            </a:extLst>
          </p:cNvPr>
          <p:cNvCxnSpPr>
            <a:cxnSpLocks/>
          </p:cNvCxnSpPr>
          <p:nvPr/>
        </p:nvCxnSpPr>
        <p:spPr>
          <a:xfrm flipH="1">
            <a:off x="2538260" y="6947276"/>
            <a:ext cx="368489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C1A0BEF3-E6DE-0E40-82FD-C901869E81F0}"/>
              </a:ext>
            </a:extLst>
          </p:cNvPr>
          <p:cNvCxnSpPr>
            <a:cxnSpLocks/>
          </p:cNvCxnSpPr>
          <p:nvPr/>
        </p:nvCxnSpPr>
        <p:spPr>
          <a:xfrm>
            <a:off x="1228075" y="6128967"/>
            <a:ext cx="0" cy="42252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4" name="Rounded Rectangle 43">
            <a:extLst>
              <a:ext uri="{FF2B5EF4-FFF2-40B4-BE49-F238E27FC236}">
                <a16:creationId xmlns:a16="http://schemas.microsoft.com/office/drawing/2014/main" id="{72EDE0A8-20C2-1C40-8616-732E0A036337}"/>
              </a:ext>
            </a:extLst>
          </p:cNvPr>
          <p:cNvSpPr/>
          <p:nvPr/>
        </p:nvSpPr>
        <p:spPr>
          <a:xfrm>
            <a:off x="4844955" y="6620826"/>
            <a:ext cx="2442725" cy="628916"/>
          </a:xfrm>
          <a:prstGeom prst="roundRect">
            <a:avLst/>
          </a:prstGeom>
          <a:solidFill>
            <a:schemeClr val="accent3">
              <a:lumMod val="40000"/>
              <a:lumOff val="6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Run ASSA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F646E06F-20C3-1F4C-A722-DFABDBE6C380}"/>
              </a:ext>
            </a:extLst>
          </p:cNvPr>
          <p:cNvCxnSpPr>
            <a:cxnSpLocks/>
          </p:cNvCxnSpPr>
          <p:nvPr/>
        </p:nvCxnSpPr>
        <p:spPr>
          <a:xfrm>
            <a:off x="4380931" y="6889902"/>
            <a:ext cx="450377" cy="167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DE6B8056-85A3-9D43-AA49-BDDB6BF32CD9}"/>
              </a:ext>
            </a:extLst>
          </p:cNvPr>
          <p:cNvCxnSpPr>
            <a:cxnSpLocks/>
          </p:cNvCxnSpPr>
          <p:nvPr/>
        </p:nvCxnSpPr>
        <p:spPr>
          <a:xfrm>
            <a:off x="6004792" y="6142615"/>
            <a:ext cx="0" cy="42252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9" name="Rounded Rectangle 48">
            <a:extLst>
              <a:ext uri="{FF2B5EF4-FFF2-40B4-BE49-F238E27FC236}">
                <a16:creationId xmlns:a16="http://schemas.microsoft.com/office/drawing/2014/main" id="{014BC016-2D3C-9D45-AA84-353BD411435F}"/>
              </a:ext>
            </a:extLst>
          </p:cNvPr>
          <p:cNvSpPr/>
          <p:nvPr/>
        </p:nvSpPr>
        <p:spPr>
          <a:xfrm>
            <a:off x="54591" y="7801780"/>
            <a:ext cx="3357348" cy="121605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Identify statistically significant lncRNA-RNA interactions and perform the enrichment analysis (compute GSEA and HGD p-values)</a:t>
            </a:r>
          </a:p>
        </p:txBody>
      </p:sp>
      <p:sp>
        <p:nvSpPr>
          <p:cNvPr id="50" name="Rounded Rectangle 49">
            <a:extLst>
              <a:ext uri="{FF2B5EF4-FFF2-40B4-BE49-F238E27FC236}">
                <a16:creationId xmlns:a16="http://schemas.microsoft.com/office/drawing/2014/main" id="{A7AAC1C9-9EAD-5949-B0A3-3C3D2E041CCD}"/>
              </a:ext>
            </a:extLst>
          </p:cNvPr>
          <p:cNvSpPr/>
          <p:nvPr/>
        </p:nvSpPr>
        <p:spPr>
          <a:xfrm>
            <a:off x="3916907" y="7801780"/>
            <a:ext cx="3357348" cy="121605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dirty="0"/>
              <a:t>Identify statistically significant lncRNA-RNA interactions and perform the enrichment analysis (compute GSEA and HGD p-values)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B4EAC192-35D7-CA49-8890-45BA5F190B30}"/>
              </a:ext>
            </a:extLst>
          </p:cNvPr>
          <p:cNvCxnSpPr>
            <a:cxnSpLocks/>
          </p:cNvCxnSpPr>
          <p:nvPr/>
        </p:nvCxnSpPr>
        <p:spPr>
          <a:xfrm>
            <a:off x="1228075" y="7302674"/>
            <a:ext cx="0" cy="42252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29E166AD-4DDD-4141-A4FB-802E6024B5D8}"/>
              </a:ext>
            </a:extLst>
          </p:cNvPr>
          <p:cNvCxnSpPr>
            <a:cxnSpLocks/>
          </p:cNvCxnSpPr>
          <p:nvPr/>
        </p:nvCxnSpPr>
        <p:spPr>
          <a:xfrm>
            <a:off x="6004792" y="7289027"/>
            <a:ext cx="0" cy="42252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4" name="Rounded Rectangle 53">
            <a:extLst>
              <a:ext uri="{FF2B5EF4-FFF2-40B4-BE49-F238E27FC236}">
                <a16:creationId xmlns:a16="http://schemas.microsoft.com/office/drawing/2014/main" id="{FA620706-F7D1-9E43-BAF7-CEF653F434F3}"/>
              </a:ext>
            </a:extLst>
          </p:cNvPr>
          <p:cNvSpPr/>
          <p:nvPr/>
        </p:nvSpPr>
        <p:spPr>
          <a:xfrm>
            <a:off x="0" y="1646090"/>
            <a:ext cx="1821865" cy="628916"/>
          </a:xfrm>
          <a:prstGeom prst="round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i="1" dirty="0"/>
              <a:t>Co-transcriptional mode</a:t>
            </a:r>
          </a:p>
        </p:txBody>
      </p:sp>
      <p:sp>
        <p:nvSpPr>
          <p:cNvPr id="55" name="Rounded Rectangle 54">
            <a:extLst>
              <a:ext uri="{FF2B5EF4-FFF2-40B4-BE49-F238E27FC236}">
                <a16:creationId xmlns:a16="http://schemas.microsoft.com/office/drawing/2014/main" id="{F1A7E08E-7F3C-1541-97BF-00588C13C1C7}"/>
              </a:ext>
            </a:extLst>
          </p:cNvPr>
          <p:cNvSpPr/>
          <p:nvPr/>
        </p:nvSpPr>
        <p:spPr>
          <a:xfrm>
            <a:off x="5363569" y="1646090"/>
            <a:ext cx="1944697" cy="628916"/>
          </a:xfrm>
          <a:prstGeom prst="round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i="1" dirty="0"/>
              <a:t>Post-transcriptional mode</a:t>
            </a:r>
          </a:p>
        </p:txBody>
      </p:sp>
    </p:spTree>
    <p:extLst>
      <p:ext uri="{BB962C8B-B14F-4D97-AF65-F5344CB8AC3E}">
        <p14:creationId xmlns:p14="http://schemas.microsoft.com/office/powerpoint/2010/main" val="36374516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</TotalTime>
  <Words>109</Words>
  <Application>Microsoft Macintosh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van</dc:creator>
  <cp:lastModifiedBy>Microsoft Office User</cp:lastModifiedBy>
  <cp:revision>82</cp:revision>
  <cp:lastPrinted>2020-04-10T10:06:00Z</cp:lastPrinted>
  <dcterms:created xsi:type="dcterms:W3CDTF">2017-02-21T13:00:32Z</dcterms:created>
  <dcterms:modified xsi:type="dcterms:W3CDTF">2020-10-23T14:42:21Z</dcterms:modified>
</cp:coreProperties>
</file>